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3" r:id="rId2"/>
    <p:sldId id="264" r:id="rId3"/>
    <p:sldId id="265" r:id="rId4"/>
    <p:sldId id="266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026" autoAdjust="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60" d="100"/>
          <a:sy n="60" d="100"/>
        </p:scale>
        <p:origin x="3187" y="43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C29A70-CACC-4958-B120-0168E7F054D0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26C3C3-A1DF-44C8-BA58-38FC98454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9096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BD915F-1F42-D64D-84B1-1805CBCF65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777721-8152-EEB0-BBF2-C54C9C6658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4905E6-F942-2748-29C0-95347CF4A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5E1BC7-0A49-282A-34BD-114C740FC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424871-177C-C698-848F-9B3FDD43B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4053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5630D9-5778-60D1-A75B-1E776AD32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FE78576-D271-4B38-BD82-3D7477CB5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F4D797-244E-1477-7E72-DB6DE47EA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25D264-CF74-B823-B9F1-707629B0D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482E76-831E-AFE1-A05E-C7CD3C9F3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6937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4D653CA-0BF1-6721-3FE8-D7D64712B6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1EF01D-7D33-5EE3-0D55-219C4CBC6D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6FCBCF-6046-D67F-C1C9-6BBE8D6EE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A531E0-4AA0-E03D-814D-964A0646E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12A3EE-F4DD-BD17-4CA4-37DF6D3EF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1141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18D184-728E-4BC0-9CA1-81DB3EF7C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36B495-33A7-E935-9C9E-F41BCB0860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B7006C-0382-11ED-795E-FFED222A6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C359DF-762D-92AE-7B98-44359B8F1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B4DBD4-C44B-86FD-C15C-24A5DFE85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908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D5EE6C-33E5-E2D3-13F4-7D18D43EE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A56D6AC-42AF-0CCB-662A-91F6C3994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B8849B-204B-DDC4-9713-54FFB5CB6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40F2CF-EA4A-28E5-CCAF-B9FD62F3D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48A5D6-6576-CD2C-8722-F43296864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485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20AD5C-3691-FD5A-5FE0-782B7303D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00B878-E1B0-9555-77B8-452BCA4011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2654C7E-111D-D075-53B1-288FB9E2E7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CC2517-7FA1-9A6C-E51B-B1D9F4E00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0437D5-C9FD-0E0E-989A-DEA687E78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D104AE-75DC-F049-60AE-8EE2456C9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229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018F24-AAA6-9FD8-6BDB-914EF3892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81BC8FE-6027-8C86-A435-658B7630A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B6F2B1-C9CC-BCA9-AFB4-1069622782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770A6C4-4430-16D9-2CEE-0317FA219E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D5F3EF7-53E5-08E5-3D86-336DABD335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33C05DF-DA35-5F15-4A8A-5B36E39E5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CDF3BE1-A9BE-9D09-4E37-371913E0C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03B8CB-DBEE-3E63-A8A3-5A3D3C559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5929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7467BC-239C-66C0-59C7-CB9A05C30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1E3922-91E1-239B-DB59-840497391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8A5A145-D51E-F455-007D-92A601299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E5513E1-0AD0-06B1-17DB-64C29DB5F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464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A84CB9D-3076-74FF-42B8-1461B48C2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E457C62-7364-A6FC-DE4A-EF1CE269E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34B1228-73B7-3523-2C1E-180AADE3F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237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AD4DFF-CF01-386F-134F-88081498A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18EE29-EDFC-5E9B-6B0A-C20628CAA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8BD7A26-6BB5-667D-6795-39D70D7F7C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7EFDFD-F198-E664-AFA6-1BFF988E8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993B9A-D885-FF94-1A8D-835111C43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229210-6696-370A-F44B-6434B6675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902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F6546F-35F4-B606-3063-50D7EE1CC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91DB06-C13A-186B-FDA3-5FABDB33EE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1DA372-1767-FDB7-C44C-AA30EBAF38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91BE45-949F-CDC3-39D8-A7E8E5347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78B926-575B-8BC8-167B-54990E310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F300FB-BAA1-C9D3-37D4-41C5126F4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4426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B487F59-B152-FCC8-0319-9EB78BF12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186AEE-0A2A-875D-97AA-F8BF40E66B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146985-3953-3BD8-D7FD-40EE639777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DFAD8-C735-4B5A-BF29-B5351C7EBBAC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AD4DD9-28BA-9094-8FC6-133D30EDFF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6197C7-043A-E36E-F3B2-0231FD0731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28970-8E26-45EF-B359-4B9E351F7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9249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2">
            <a:extLst>
              <a:ext uri="{FF2B5EF4-FFF2-40B4-BE49-F238E27FC236}">
                <a16:creationId xmlns:a16="http://schemas.microsoft.com/office/drawing/2014/main" id="{70BC23BE-FB21-2F8D-651D-702181CA89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1999" y="795891"/>
            <a:ext cx="2282171" cy="384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A28 vs R8Q10</a:t>
            </a:r>
            <a:endParaRPr lang="zh-CN" sz="1400" b="1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A468F11-8E2E-13F7-7008-C096623AF3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025" y="0"/>
            <a:ext cx="71056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5133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E0EE6DB3-E8FB-112F-FA8A-15A3B3B4C8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9705" y="0"/>
            <a:ext cx="3584838" cy="6858000"/>
          </a:xfrm>
          <a:prstGeom prst="rect">
            <a:avLst/>
          </a:prstGeom>
        </p:spPr>
      </p:pic>
      <p:sp>
        <p:nvSpPr>
          <p:cNvPr id="4" name="文本框 2">
            <a:extLst>
              <a:ext uri="{FF2B5EF4-FFF2-40B4-BE49-F238E27FC236}">
                <a16:creationId xmlns:a16="http://schemas.microsoft.com/office/drawing/2014/main" id="{7AC7A7FB-4ED3-B45F-A429-A30E26A539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4542" y="322363"/>
            <a:ext cx="2282171" cy="384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A28 vs YH25005</a:t>
            </a:r>
            <a:endParaRPr lang="zh-CN" sz="1400" b="1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63295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58816F8-089E-0843-5B72-A9C722FE91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057" y="0"/>
            <a:ext cx="3603796" cy="6858000"/>
          </a:xfrm>
          <a:prstGeom prst="rect">
            <a:avLst/>
          </a:prstGeom>
        </p:spPr>
      </p:pic>
      <p:sp>
        <p:nvSpPr>
          <p:cNvPr id="5" name="文本框 2">
            <a:extLst>
              <a:ext uri="{FF2B5EF4-FFF2-40B4-BE49-F238E27FC236}">
                <a16:creationId xmlns:a16="http://schemas.microsoft.com/office/drawing/2014/main" id="{EBE72A02-587F-888A-1484-4A247302A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6581" y="307395"/>
            <a:ext cx="2282171" cy="384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SW vs R8Q10</a:t>
            </a:r>
            <a:endParaRPr lang="zh-CN" sz="1400" b="1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3805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35646425-BDA3-A7EF-FF92-AE9C573FF3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6871" y="-68094"/>
            <a:ext cx="4451662" cy="6812736"/>
          </a:xfrm>
          <a:prstGeom prst="rect">
            <a:avLst/>
          </a:prstGeom>
        </p:spPr>
      </p:pic>
      <p:sp>
        <p:nvSpPr>
          <p:cNvPr id="15" name="Rectangle 20">
            <a:extLst>
              <a:ext uri="{FF2B5EF4-FFF2-40B4-BE49-F238E27FC236}">
                <a16:creationId xmlns:a16="http://schemas.microsoft.com/office/drawing/2014/main" id="{808BEBD8-DEC8-66B9-8E41-9EC491557C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1987" y="6621209"/>
            <a:ext cx="997031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. Heatmap of the selected DEGs related to lipid biosynthesis, transport, and metabolism</a:t>
            </a:r>
          </a:p>
        </p:txBody>
      </p:sp>
      <p:sp>
        <p:nvSpPr>
          <p:cNvPr id="4" name="文本框 2">
            <a:extLst>
              <a:ext uri="{FF2B5EF4-FFF2-40B4-BE49-F238E27FC236}">
                <a16:creationId xmlns:a16="http://schemas.microsoft.com/office/drawing/2014/main" id="{A37E1BBA-475F-0AEB-36F3-E1561F235F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5399" y="395841"/>
            <a:ext cx="2282171" cy="384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SW vs YH25005</a:t>
            </a:r>
            <a:endParaRPr lang="zh-CN" sz="1400" b="1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8156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41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yu Yu</dc:creator>
  <cp:lastModifiedBy>MDPI</cp:lastModifiedBy>
  <cp:revision>8</cp:revision>
  <dcterms:created xsi:type="dcterms:W3CDTF">2024-01-28T08:55:23Z</dcterms:created>
  <dcterms:modified xsi:type="dcterms:W3CDTF">2024-03-07T09:33:25Z</dcterms:modified>
</cp:coreProperties>
</file>